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6"/>
  </p:notesMasterIdLst>
  <p:sldIdLst>
    <p:sldId id="274" r:id="rId2"/>
    <p:sldId id="259" r:id="rId3"/>
    <p:sldId id="260" r:id="rId4"/>
    <p:sldId id="261" r:id="rId5"/>
    <p:sldId id="262" r:id="rId6"/>
    <p:sldId id="263" r:id="rId7"/>
    <p:sldId id="257" r:id="rId8"/>
    <p:sldId id="258" r:id="rId9"/>
    <p:sldId id="264" r:id="rId10"/>
    <p:sldId id="269" r:id="rId11"/>
    <p:sldId id="271" r:id="rId12"/>
    <p:sldId id="272" r:id="rId13"/>
    <p:sldId id="273" r:id="rId14"/>
    <p:sldId id="270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77"/>
    <p:restoredTop sz="95267"/>
  </p:normalViewPr>
  <p:slideViewPr>
    <p:cSldViewPr snapToGrid="0">
      <p:cViewPr varScale="1">
        <p:scale>
          <a:sx n="66" d="100"/>
          <a:sy n="66" d="100"/>
        </p:scale>
        <p:origin x="66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68CE3D-9AA0-E745-9BC9-E6C052411013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D3D174-D546-D044-95F9-E295DA3E04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627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MACRO PHOTO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94820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TRANSILLUMINATOR DL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90128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TRANSILLUMINATOR DB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87991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TRANSILLUMINATOR B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12674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TRANSILLUMINATOR MB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1230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MICROSCOPE 0.4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2740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MICROSCOPE 0.6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42160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MICROSCOPE 2.5 MESIA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74687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MICROSCOPE 2.5 DISTA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50583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DIAGNOCAM PLAIN INTRA-ORAL PHOTO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14701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DIAGNOCAM TRANSILLUMINATOR PHOTO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73972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TRANSILLUMINATOR ML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7012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>
                <a:solidFill>
                  <a:srgbClr val="000000"/>
                </a:solidFill>
                <a:effectLst/>
                <a:latin typeface="Helvetica" pitchFamily="2" charset="0"/>
              </a:rPr>
              <a:t>TRANSILLUMINATOR 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D3D174-D546-D044-95F9-E295DA3E043E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9714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3EFA6-FDCB-16D9-69EF-0FD84E6AE8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DAECBF-FF50-38CF-E905-5DF2DE62D1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8EABE2-8CA0-E43D-234C-4C29A26B0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D8B4F1-B26B-CFE3-D985-1CA2D4BFD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721A33-F02C-E778-9B09-146E99954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488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DFA4F-5079-DA49-BE99-39952D3022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70C5FF-C0B6-12D7-CA2C-8C0BD888F7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2E0E2A-69CC-386E-75CF-CD26E5D05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50A6B5-08FA-D6EC-5168-97FD66D64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44FC7B-C60F-CFDA-09D9-2F6139973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507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47CF3C0-BC98-2EFE-A1AA-0D8EAD75FF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DB43FB-5FDF-65DC-D0A6-B34BCFC627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C3D75F-614C-011F-9E11-40749732D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38B31C-6C91-C19B-3B29-0B792B09D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16C15E-3687-FC49-EA8E-002514589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313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7FAC8-AF77-CCF7-AFF9-3AB2F29BC9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430339-2C2B-DD1E-6FD0-F40AB0A32A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7AA921-6DA3-2841-0543-146DC1F1C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203D60-4892-442C-5153-AE640072B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54DF79-E286-7041-45B7-31E50C597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420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CD3A38-5252-049E-7F32-E6852D1311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78A33F-E9F2-D513-341F-7FC09443CD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D0B9D2-DD91-EC5B-1B7B-A2237103D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032D2D-899B-3BE3-E1CB-DF406A4D8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5E4BF2-67AC-CC4B-AB5B-FE52E7A87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640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1CEE51-A801-D671-B02F-495DBB81AB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7AEF6C-5A92-63E8-B4E8-D34D5227F8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F15A7C-7791-BF20-55FA-EE50DB22B6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4B9554-BABD-8CD0-DEAA-313DE5E46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04CCD4-15A7-C6C3-2647-85F6090419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2D1237-CB1A-0D36-9834-6B3EE7243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991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AB28FA-7569-A349-4DDF-B7F7974A85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EEBC37-B34F-E41D-A16E-2C32EAAEFC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9E4885-3034-33D4-0564-AA2FA5BC65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80D4CD-7B59-0CD4-EC8A-81211B84E3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035F220-206A-ED5C-423E-0707EF8642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7719EC-B445-7A73-6415-CDB300B16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63BFCE-7C3C-CCAD-A024-B3EB49E31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6A1CFA1-46CD-B81C-E8E4-6EE371208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812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397082-04FE-327E-0AAE-5A3420C428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A6B7D4B-2FC0-53C5-B60A-75CED0CF5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690659D-6448-6E7E-250D-2435CC2F9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D639B6-A892-0A9C-8D7E-E34B7ED91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986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1633B0F-4175-6E54-5699-35275C71C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2CD76D8-C17B-AC4F-1ED1-B987F6953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6F49F1-3061-B710-8C66-83051B72D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043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F8780E-6BE2-0A0F-3829-C4EDE961E6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3AC911-3AAB-0E58-1928-1AA543C3F9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1AECD8-F16C-DA0E-61FA-97B3ACC720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976740-60BF-B611-C477-21771D320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DAB206-4553-64F0-445B-F6C04E497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2E9A0A-0100-8A74-DBE7-C436F6CED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99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156BE-C038-6DF7-CC3F-B6F6BA54D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05F17B-D8BD-CE49-7B63-FC2B0575C7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2D0517-8509-81E7-0E90-CC2E4EDA46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360C5B-D1D5-81DA-230B-E93173627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6EDD73-AC8E-7BFA-884A-3B65A0CBB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0C83EA-1A17-4DAD-DAAE-30867031D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449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33565C-010B-5A6C-FF72-1A71A55B6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8A43C3-DFD8-AC97-E149-1EA30877D5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68619F-002B-AB62-0090-CE67D2B2BA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CEA473-02FA-E149-88E0-C30A92EFA562}" type="datetimeFigureOut">
              <a:rPr lang="en-US" smtClean="0"/>
              <a:t>8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9B1A04-8640-8578-5539-37FF7D8B70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B0309E-00FE-8970-7EE6-2F2D0A1227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5EFF78-5839-C948-9DE5-9C6D63CBE2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890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37719D6-705B-E984-3084-E3C6209AC5F1}"/>
              </a:ext>
            </a:extLst>
          </p:cNvPr>
          <p:cNvSpPr txBox="1"/>
          <p:nvPr/>
        </p:nvSpPr>
        <p:spPr>
          <a:xfrm>
            <a:off x="2887136" y="2226878"/>
            <a:ext cx="68698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ample of How Index Tests were Presented to Examiners for Data Collectio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B46CE68-3AFA-7499-574F-8882DFE5DC0A}"/>
              </a:ext>
            </a:extLst>
          </p:cNvPr>
          <p:cNvSpPr txBox="1"/>
          <p:nvPr/>
        </p:nvSpPr>
        <p:spPr>
          <a:xfrm>
            <a:off x="3611200" y="3059668"/>
            <a:ext cx="542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  <a:r>
              <a:rPr lang="en-US" b="1" dirty="0"/>
              <a:t>NOTE: </a:t>
            </a:r>
            <a:r>
              <a:rPr lang="en-US" dirty="0"/>
              <a:t>Speaker notes were not shown to examiners*</a:t>
            </a:r>
          </a:p>
        </p:txBody>
      </p:sp>
    </p:spTree>
    <p:extLst>
      <p:ext uri="{BB962C8B-B14F-4D97-AF65-F5344CB8AC3E}">
        <p14:creationId xmlns:p14="http://schemas.microsoft.com/office/powerpoint/2010/main" val="5382696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 descr="A close up of a yellow object&#10;&#10;Description automatically generated">
            <a:extLst>
              <a:ext uri="{FF2B5EF4-FFF2-40B4-BE49-F238E27FC236}">
                <a16:creationId xmlns:a16="http://schemas.microsoft.com/office/drawing/2014/main" id="{7FACD109-6FBE-FAB3-E765-E6471F3E747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71" r="1" b="1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074082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 descr="A close-up of a tooth&#10;&#10;Description automatically generated">
            <a:extLst>
              <a:ext uri="{FF2B5EF4-FFF2-40B4-BE49-F238E27FC236}">
                <a16:creationId xmlns:a16="http://schemas.microsoft.com/office/drawing/2014/main" id="{F40B108A-01DC-9B37-CC19-A948DB315F4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9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385351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 descr="A close up of a yellow object&#10;&#10;Description automatically generated">
            <a:extLst>
              <a:ext uri="{FF2B5EF4-FFF2-40B4-BE49-F238E27FC236}">
                <a16:creationId xmlns:a16="http://schemas.microsoft.com/office/drawing/2014/main" id="{624EE4AC-BC17-1741-6C3E-71C2CFA5CA3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19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675521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 descr="A close-up of a tooth&#10;&#10;Description automatically generated">
            <a:extLst>
              <a:ext uri="{FF2B5EF4-FFF2-40B4-BE49-F238E27FC236}">
                <a16:creationId xmlns:a16="http://schemas.microsoft.com/office/drawing/2014/main" id="{98431901-0751-1D5F-5D8D-B5F4077F763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26" r="-1" b="-1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010975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 descr="A close up of a tooth&#10;&#10;Description automatically generated">
            <a:extLst>
              <a:ext uri="{FF2B5EF4-FFF2-40B4-BE49-F238E27FC236}">
                <a16:creationId xmlns:a16="http://schemas.microsoft.com/office/drawing/2014/main" id="{E1084B50-FA4B-F5C2-E21C-FCB103B87E5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872" b="1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6455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tooth&#10;&#10;Description automatically generated">
            <a:extLst>
              <a:ext uri="{FF2B5EF4-FFF2-40B4-BE49-F238E27FC236}">
                <a16:creationId xmlns:a16="http://schemas.microsoft.com/office/drawing/2014/main" id="{DF69B8C1-9654-04C8-AF8D-78F7FB81C08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19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58402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omparison of a tooth model&#10;&#10;Description automatically generated with medium confidence">
            <a:extLst>
              <a:ext uri="{FF2B5EF4-FFF2-40B4-BE49-F238E27FC236}">
                <a16:creationId xmlns:a16="http://schemas.microsoft.com/office/drawing/2014/main" id="{CE614E9B-C6BA-AD08-4B07-07B3967CC06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19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11286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teeth&#10;&#10;Description automatically generated">
            <a:extLst>
              <a:ext uri="{FF2B5EF4-FFF2-40B4-BE49-F238E27FC236}">
                <a16:creationId xmlns:a16="http://schemas.microsoft.com/office/drawing/2014/main" id="{993513E5-290D-E98F-D4BB-4B6063027FD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26" r="-1" b="-1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35407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lose-up of a human teeth&#10;&#10;Description automatically generated">
            <a:extLst>
              <a:ext uri="{FF2B5EF4-FFF2-40B4-BE49-F238E27FC236}">
                <a16:creationId xmlns:a16="http://schemas.microsoft.com/office/drawing/2014/main" id="{142BFEB4-9F64-8976-41F6-48306666DC7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899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98811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lose-up of teeth&#10;&#10;Description automatically generated">
            <a:extLst>
              <a:ext uri="{FF2B5EF4-FFF2-40B4-BE49-F238E27FC236}">
                <a16:creationId xmlns:a16="http://schemas.microsoft.com/office/drawing/2014/main" id="{D32A9459-169E-0EA0-06A0-EC54309AF1E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26" r="-1" b="-1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37545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Close-up of a human tooth&#10;&#10;Description automatically generated">
            <a:extLst>
              <a:ext uri="{FF2B5EF4-FFF2-40B4-BE49-F238E27FC236}">
                <a16:creationId xmlns:a16="http://schemas.microsoft.com/office/drawing/2014/main" id="{F7302282-89C3-37F5-EEC3-385D1CAEE9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12192000" cy="68603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18170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 descr="A close-up of a human tooth&#10;&#10;Description automatically generated">
            <a:extLst>
              <a:ext uri="{FF2B5EF4-FFF2-40B4-BE49-F238E27FC236}">
                <a16:creationId xmlns:a16="http://schemas.microsoft.com/office/drawing/2014/main" id="{9BE309A3-0FFA-53FF-EC0E-FCA1C1AF01E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461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36068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 descr="A close up of a yellow tooth&#10;&#10;Description automatically generated">
            <a:extLst>
              <a:ext uri="{FF2B5EF4-FFF2-40B4-BE49-F238E27FC236}">
                <a16:creationId xmlns:a16="http://schemas.microsoft.com/office/drawing/2014/main" id="{32228CDA-7D5A-1332-D994-A4039370705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872" b="1"/>
          <a:stretch/>
        </p:blipFill>
        <p:spPr>
          <a:xfrm>
            <a:off x="20" y="1282"/>
            <a:ext cx="12191980" cy="6856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6778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67</Words>
  <Application>Microsoft Office PowerPoint</Application>
  <PresentationFormat>Widescreen</PresentationFormat>
  <Paragraphs>28</Paragraphs>
  <Slides>14</Slides>
  <Notes>1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ptos</vt:lpstr>
      <vt:lpstr>Aptos Display</vt:lpstr>
      <vt:lpstr>Arial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eronica Kindaro</dc:creator>
  <cp:lastModifiedBy>D, Kirubasankari -</cp:lastModifiedBy>
  <cp:revision>2</cp:revision>
  <dcterms:created xsi:type="dcterms:W3CDTF">2024-08-07T12:51:59Z</dcterms:created>
  <dcterms:modified xsi:type="dcterms:W3CDTF">2024-08-12T10:12:14Z</dcterms:modified>
</cp:coreProperties>
</file>